
<file path=[Content_Types].xml><?xml version="1.0" encoding="utf-8"?>
<Types xmlns="http://schemas.openxmlformats.org/package/2006/content-types">
  <Default Extension="bin" ContentType="application/vnd.openxmlformats-officedocument.oleObject"/>
  <Default Extension="jpeg" ContentType="image/jpeg"/>
  <Default Extension="rels" ContentType="application/vnd.openxmlformats-package.relationships+xml"/>
  <Default Extension="wmf" ContentType="image/x-wm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9" r:id="rId3"/>
    <p:sldId id="260" r:id="rId4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24" autoAdjust="0"/>
    <p:restoredTop sz="94660"/>
  </p:normalViewPr>
  <p:slideViewPr>
    <p:cSldViewPr snapToGrid="0">
      <p:cViewPr varScale="1">
        <p:scale>
          <a:sx n="87" d="100"/>
          <a:sy n="87" d="100"/>
        </p:scale>
        <p:origin x="530" y="4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F0893D2-E657-4551-AF2D-3E895C808B6D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E163733A-6911-4E6B-86DF-1FF2F255636F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F27D8E9-B06E-48AB-96E0-C6B9496AC32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8D1065-EF39-4704-A209-2E643A10BD2A}" type="datetimeFigureOut">
              <a:rPr lang="en-GB" smtClean="0"/>
              <a:t>27/07/2021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5077C21-74A0-47B6-95C2-98DAB5AEEA1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371B96E-AD0C-4C23-A782-53B52EC1600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051B6A-19BB-427F-899D-B05263C5468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3514960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A849364-CD10-40AF-89D7-BDB90FBACD5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44C73CA0-C473-4ED4-838A-57929E965C6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221F543-3016-4C27-A075-A5BA33F1E7D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8D1065-EF39-4704-A209-2E643A10BD2A}" type="datetimeFigureOut">
              <a:rPr lang="en-GB" smtClean="0"/>
              <a:t>27/07/2021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2589E7C-C07F-4759-92FA-40D38D98A18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3538D47-5309-49C5-ACCF-714E439D9EC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051B6A-19BB-427F-899D-B05263C5468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1728354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D836F870-4A5F-4C7A-9687-7E47A475E29C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D8756001-258A-4E3A-B23C-EDAB73A60F6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B516ACA-460D-412A-9E23-175A0B1F649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8D1065-EF39-4704-A209-2E643A10BD2A}" type="datetimeFigureOut">
              <a:rPr lang="en-GB" smtClean="0"/>
              <a:t>27/07/2021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FE00D10-24E4-43DB-9A5C-29AB70AC30F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6090029-BE1B-4643-B158-F825FAD16BA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051B6A-19BB-427F-899D-B05263C5468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6849189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6A5512A-B958-4B13-A3D2-7754FC2C215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5D77C3D-87B2-45AE-846F-1C17DFC662DE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79A6D37-7924-4AD9-BA19-E672B8A814A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8D1065-EF39-4704-A209-2E643A10BD2A}" type="datetimeFigureOut">
              <a:rPr lang="en-GB" smtClean="0"/>
              <a:t>27/07/2021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34652C0-EFAB-4A5A-8D8C-FB4E7B95CA3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9F72CFF-4BC1-47CA-98F6-27E4083FFBF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051B6A-19BB-427F-899D-B05263C5468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9453779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518574B-3155-4645-835E-B64EEB10B1A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2543B33-E77E-4363-95DE-3F473D20B4F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E70B3E5-8F3F-4AE8-98DC-48AF5C59222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8D1065-EF39-4704-A209-2E643A10BD2A}" type="datetimeFigureOut">
              <a:rPr lang="en-GB" smtClean="0"/>
              <a:t>27/07/2021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855EB6C-1201-4138-B989-D2E3DF7A163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5C3703A-D9F3-48E5-B42A-891CC4507BF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051B6A-19BB-427F-899D-B05263C5468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6589318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53C9DE4-E37F-4D04-978F-DD6FEC26358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0A487AE-9CA9-43AE-9667-8BA75BD196D9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DFBA62CB-FE2A-4F64-857B-E0B82C294C3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7E6AF3E-F4AB-452F-997E-84164B33CF8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8D1065-EF39-4704-A209-2E643A10BD2A}" type="datetimeFigureOut">
              <a:rPr lang="en-GB" smtClean="0"/>
              <a:t>27/07/2021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8A84472F-10F8-48B6-8BF4-D88D9FCDA4F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662F5EF-C8D6-4A9D-AB26-9F9F63FAD3D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051B6A-19BB-427F-899D-B05263C5468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669018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ED4AEFC-BFCA-48B7-A89D-AF4BF862C76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CA1641F-9BDA-4096-9F35-8057C882448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46F8E990-8ADC-4D72-9DDE-A1B543FD28B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6D76FA04-B501-4334-946C-CC2DC17D9762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B9E307E1-7354-40CE-ADE1-E3EE2D47E14E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C7830A1D-15A2-495C-ACC1-CAA4355250B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8D1065-EF39-4704-A209-2E643A10BD2A}" type="datetimeFigureOut">
              <a:rPr lang="en-GB" smtClean="0"/>
              <a:t>27/07/2021</a:t>
            </a:fld>
            <a:endParaRPr lang="en-GB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2521B3FE-5CED-40A2-8BEB-92F0C11F0A9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E92F5C44-8212-487C-85DC-C421169ADC7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051B6A-19BB-427F-899D-B05263C5468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3268509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953A511-D9DC-4CBC-8C91-BD026FB8FF7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DEC6049D-CF9E-4241-92EC-BC826953391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8D1065-EF39-4704-A209-2E643A10BD2A}" type="datetimeFigureOut">
              <a:rPr lang="en-GB" smtClean="0"/>
              <a:t>27/07/2021</a:t>
            </a:fld>
            <a:endParaRPr lang="en-GB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49B4A6DD-3E00-410B-B365-EEBEEFBB511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80F15115-8309-46B6-BE23-B01BB67012B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051B6A-19BB-427F-899D-B05263C5468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8890133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CC596F75-FAF9-494C-9E7E-8B1F0CF8D6B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8D1065-EF39-4704-A209-2E643A10BD2A}" type="datetimeFigureOut">
              <a:rPr lang="en-GB" smtClean="0"/>
              <a:t>27/07/2021</a:t>
            </a:fld>
            <a:endParaRPr lang="en-GB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10C7B472-34CE-4779-B03E-19533D57675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C134DC9B-3C98-4FC6-948B-94F32879755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051B6A-19BB-427F-899D-B05263C5468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2854444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5E3B31C-E390-4363-9A80-463DA57E570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1E597B9-81CE-4441-9E22-4B53B7E5A638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8B662D59-12F9-4153-BA08-9119AB9CF81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B90676F-B522-4DDB-BA82-46C535B5C7B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8D1065-EF39-4704-A209-2E643A10BD2A}" type="datetimeFigureOut">
              <a:rPr lang="en-GB" smtClean="0"/>
              <a:t>27/07/2021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5255372-EBF3-40DC-8A37-F13499F1CEF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EDAFBB2-38EE-45E9-A373-2CBB191EF30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051B6A-19BB-427F-899D-B05263C5468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8102196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7C3B1EC-7BEF-41F5-881E-8142CCE9BD0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C1219100-FEB4-4944-B726-20210B8AD15C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B856A746-0168-4C59-BD9B-ABDEB2BC506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C923352-DB3B-42E9-A45A-C133FD12C8C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8D1065-EF39-4704-A209-2E643A10BD2A}" type="datetimeFigureOut">
              <a:rPr lang="en-GB" smtClean="0"/>
              <a:t>27/07/2021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A241F2A-A03F-4C03-8CAA-A86190ED6F4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AEF60BEF-87D5-4E46-97DA-68862503D79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051B6A-19BB-427F-899D-B05263C5468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2655261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1E0E7FFB-E2A0-4021-8CA8-8426B723592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E17A022-18ED-4801-8ECF-921AB7ED00C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1CA4EF1-E8A6-4497-A367-8AE7538C230C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98D1065-EF39-4704-A209-2E643A10BD2A}" type="datetimeFigureOut">
              <a:rPr lang="en-GB" smtClean="0"/>
              <a:t>27/07/2021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D43EB57-37D1-4F67-AFA2-A0D054AD4E56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3CB422C-B28D-4DB9-AE10-F7A3D5127B1D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F051B6A-19BB-427F-899D-B05263C5468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0656721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wmf"/><Relationship Id="rId2" Type="http://schemas.openxmlformats.org/officeDocument/2006/relationships/oleObject" Target="../embeddings/oleObject1.bin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wmf"/><Relationship Id="rId2" Type="http://schemas.openxmlformats.org/officeDocument/2006/relationships/oleObject" Target="../embeddings/oleObject2.bin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86E7851-2981-4222-8337-326FDF4FDACE}"/>
              </a:ext>
            </a:extLst>
          </p:cNvPr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r>
              <a:rPr lang="en-US" dirty="0"/>
              <a:t>Figure 1G</a:t>
            </a:r>
            <a:endParaRPr lang="en-GB" dirty="0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58A67544-1301-4C06-AE5B-FB52D82DB092}"/>
              </a:ext>
            </a:extLst>
          </p:cNvPr>
          <p:cNvSpPr>
            <a:spLocks noGrp="1"/>
          </p:cNvSpPr>
          <p:nvPr>
            <p:ph type="subTitle" idx="1"/>
          </p:nvPr>
        </p:nvSpPr>
        <p:spPr/>
        <p:txBody>
          <a:bodyPr/>
          <a:lstStyle/>
          <a:p>
            <a:r>
              <a:rPr lang="en-US" dirty="0"/>
              <a:t>Source data: immunoblots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380338500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1" name="Object 20">
            <a:extLst>
              <a:ext uri="{FF2B5EF4-FFF2-40B4-BE49-F238E27FC236}">
                <a16:creationId xmlns:a16="http://schemas.microsoft.com/office/drawing/2014/main" id="{53266997-ADBB-4883-8CFE-9828E1471F5E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111276450"/>
              </p:ext>
            </p:extLst>
          </p:nvPr>
        </p:nvGraphicFramePr>
        <p:xfrm>
          <a:off x="4203464" y="649253"/>
          <a:ext cx="3785072" cy="5602371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r:id="rId2" imgW="1556640" imgH="2305080" progId="">
                  <p:embed/>
                </p:oleObj>
              </mc:Choice>
              <mc:Fallback>
                <p:oleObj r:id="rId2" imgW="1556640" imgH="2305080" progId="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4203464" y="649253"/>
                        <a:ext cx="3785072" cy="5602371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5" name="Rectangle 4">
            <a:extLst>
              <a:ext uri="{FF2B5EF4-FFF2-40B4-BE49-F238E27FC236}">
                <a16:creationId xmlns:a16="http://schemas.microsoft.com/office/drawing/2014/main" id="{2806D42B-584E-47F7-956E-46B5D93A1862}"/>
              </a:ext>
            </a:extLst>
          </p:cNvPr>
          <p:cNvSpPr/>
          <p:nvPr/>
        </p:nvSpPr>
        <p:spPr>
          <a:xfrm>
            <a:off x="6967959" y="405114"/>
            <a:ext cx="1221130" cy="6117220"/>
          </a:xfrm>
          <a:prstGeom prst="rect">
            <a:avLst/>
          </a:prstGeom>
          <a:noFill/>
          <a:ln w="38100"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8FB689F4-5509-485C-B38E-7CB872691B39}"/>
              </a:ext>
            </a:extLst>
          </p:cNvPr>
          <p:cNvSpPr txBox="1"/>
          <p:nvPr/>
        </p:nvSpPr>
        <p:spPr>
          <a:xfrm>
            <a:off x="8582628" y="3316147"/>
            <a:ext cx="1527469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Anti-GIV </a:t>
            </a:r>
            <a:r>
              <a:rPr lang="en-US" dirty="0" err="1"/>
              <a:t>CCAb</a:t>
            </a:r>
            <a:endParaRPr lang="en-US" dirty="0"/>
          </a:p>
          <a:p>
            <a:r>
              <a:rPr lang="en-US" dirty="0"/>
              <a:t>1:500</a:t>
            </a:r>
            <a:endParaRPr lang="en-GB" dirty="0"/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07D475A3-4F2E-4F28-A736-BF41FE19F94C}"/>
              </a:ext>
            </a:extLst>
          </p:cNvPr>
          <p:cNvSpPr txBox="1"/>
          <p:nvPr/>
        </p:nvSpPr>
        <p:spPr>
          <a:xfrm>
            <a:off x="3597208" y="983848"/>
            <a:ext cx="60625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250-</a:t>
            </a:r>
            <a:endParaRPr lang="en-GB" dirty="0"/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2D9A22D3-8E3D-4322-97A0-A143226EDE2E}"/>
              </a:ext>
            </a:extLst>
          </p:cNvPr>
          <p:cNvSpPr txBox="1"/>
          <p:nvPr/>
        </p:nvSpPr>
        <p:spPr>
          <a:xfrm>
            <a:off x="3597208" y="1591532"/>
            <a:ext cx="60625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150-</a:t>
            </a:r>
            <a:endParaRPr lang="en-GB" dirty="0"/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11CC66E3-D313-41BF-B178-AD0A29F88AD9}"/>
              </a:ext>
            </a:extLst>
          </p:cNvPr>
          <p:cNvSpPr txBox="1"/>
          <p:nvPr/>
        </p:nvSpPr>
        <p:spPr>
          <a:xfrm>
            <a:off x="3597208" y="2374739"/>
            <a:ext cx="60625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100-</a:t>
            </a:r>
            <a:endParaRPr lang="en-GB" dirty="0"/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8E6DE5CD-88D1-4A80-963A-292BCFC03A4B}"/>
              </a:ext>
            </a:extLst>
          </p:cNvPr>
          <p:cNvSpPr txBox="1"/>
          <p:nvPr/>
        </p:nvSpPr>
        <p:spPr>
          <a:xfrm>
            <a:off x="3703567" y="3131481"/>
            <a:ext cx="60625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75-</a:t>
            </a:r>
            <a:endParaRPr lang="en-GB" dirty="0"/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734B472D-7CFF-4F12-9C46-D98ACA95B39F}"/>
              </a:ext>
            </a:extLst>
          </p:cNvPr>
          <p:cNvSpPr txBox="1"/>
          <p:nvPr/>
        </p:nvSpPr>
        <p:spPr>
          <a:xfrm>
            <a:off x="3699783" y="4095983"/>
            <a:ext cx="60625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50-</a:t>
            </a:r>
            <a:endParaRPr lang="en-GB" dirty="0"/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5D189C33-4C4A-4AFA-AC9F-1DFFB27392C0}"/>
              </a:ext>
            </a:extLst>
          </p:cNvPr>
          <p:cNvSpPr txBox="1"/>
          <p:nvPr/>
        </p:nvSpPr>
        <p:spPr>
          <a:xfrm>
            <a:off x="3711614" y="5689486"/>
            <a:ext cx="60625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37-</a:t>
            </a:r>
            <a:endParaRPr lang="en-GB" dirty="0"/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FD8223B3-CAEC-4A1F-9962-C2E034E82172}"/>
              </a:ext>
            </a:extLst>
          </p:cNvPr>
          <p:cNvSpPr txBox="1"/>
          <p:nvPr/>
        </p:nvSpPr>
        <p:spPr>
          <a:xfrm>
            <a:off x="4861367" y="306729"/>
            <a:ext cx="130362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Testes 1-2-3</a:t>
            </a:r>
            <a:endParaRPr lang="en-GB" dirty="0"/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C666C614-5994-4B30-8F93-885CF48B7A11}"/>
              </a:ext>
            </a:extLst>
          </p:cNvPr>
          <p:cNvSpPr txBox="1"/>
          <p:nvPr/>
        </p:nvSpPr>
        <p:spPr>
          <a:xfrm>
            <a:off x="5359079" y="193877"/>
            <a:ext cx="130362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Testes 1-2-3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250073665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7" name="Object 6">
            <a:extLst>
              <a:ext uri="{FF2B5EF4-FFF2-40B4-BE49-F238E27FC236}">
                <a16:creationId xmlns:a16="http://schemas.microsoft.com/office/drawing/2014/main" id="{9173BA6C-39B8-4A2B-B283-727A79B0E0DD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134965350"/>
              </p:ext>
            </p:extLst>
          </p:nvPr>
        </p:nvGraphicFramePr>
        <p:xfrm>
          <a:off x="4190035" y="632796"/>
          <a:ext cx="4038071" cy="566383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r:id="rId2" imgW="1826280" imgH="2561400" progId="">
                  <p:embed/>
                </p:oleObj>
              </mc:Choice>
              <mc:Fallback>
                <p:oleObj r:id="rId2" imgW="1826280" imgH="2561400" progId="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4190035" y="632796"/>
                        <a:ext cx="4038071" cy="566383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8" name="Rectangle 7">
            <a:extLst>
              <a:ext uri="{FF2B5EF4-FFF2-40B4-BE49-F238E27FC236}">
                <a16:creationId xmlns:a16="http://schemas.microsoft.com/office/drawing/2014/main" id="{0E4399BE-10F0-426E-894E-80E0FECC9DF5}"/>
              </a:ext>
            </a:extLst>
          </p:cNvPr>
          <p:cNvSpPr/>
          <p:nvPr/>
        </p:nvSpPr>
        <p:spPr>
          <a:xfrm>
            <a:off x="6662451" y="561372"/>
            <a:ext cx="995423" cy="5931503"/>
          </a:xfrm>
          <a:prstGeom prst="rect">
            <a:avLst/>
          </a:prstGeom>
          <a:noFill/>
          <a:ln w="38100"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A237C1B4-8C61-4921-8E51-DE2268F23E53}"/>
              </a:ext>
            </a:extLst>
          </p:cNvPr>
          <p:cNvSpPr txBox="1"/>
          <p:nvPr/>
        </p:nvSpPr>
        <p:spPr>
          <a:xfrm>
            <a:off x="8582628" y="3316147"/>
            <a:ext cx="1199303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Anti-</a:t>
            </a:r>
            <a:r>
              <a:rPr lang="en-US" dirty="0" err="1"/>
              <a:t>pYGIV</a:t>
            </a:r>
            <a:endParaRPr lang="en-US" dirty="0"/>
          </a:p>
          <a:p>
            <a:r>
              <a:rPr lang="en-US" dirty="0"/>
              <a:t>1:250</a:t>
            </a:r>
            <a:endParaRPr lang="en-GB" dirty="0"/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D7411E2B-4937-4708-BAE1-58B6A60CF720}"/>
              </a:ext>
            </a:extLst>
          </p:cNvPr>
          <p:cNvSpPr txBox="1"/>
          <p:nvPr/>
        </p:nvSpPr>
        <p:spPr>
          <a:xfrm>
            <a:off x="3597208" y="983848"/>
            <a:ext cx="60625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250-</a:t>
            </a:r>
            <a:endParaRPr lang="en-GB" dirty="0"/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A287FAC5-2337-4553-BC42-963AD48C0C45}"/>
              </a:ext>
            </a:extLst>
          </p:cNvPr>
          <p:cNvSpPr txBox="1"/>
          <p:nvPr/>
        </p:nvSpPr>
        <p:spPr>
          <a:xfrm>
            <a:off x="3597208" y="1591532"/>
            <a:ext cx="60625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150-</a:t>
            </a:r>
            <a:endParaRPr lang="en-GB" dirty="0"/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63BF2DE3-5A2F-4FCD-920B-39B1C40F9966}"/>
              </a:ext>
            </a:extLst>
          </p:cNvPr>
          <p:cNvSpPr txBox="1"/>
          <p:nvPr/>
        </p:nvSpPr>
        <p:spPr>
          <a:xfrm>
            <a:off x="3597208" y="2374739"/>
            <a:ext cx="60625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100-</a:t>
            </a:r>
            <a:endParaRPr lang="en-GB" dirty="0"/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B4481C9E-F958-4DD3-B083-7633EEB37611}"/>
              </a:ext>
            </a:extLst>
          </p:cNvPr>
          <p:cNvSpPr txBox="1"/>
          <p:nvPr/>
        </p:nvSpPr>
        <p:spPr>
          <a:xfrm>
            <a:off x="3703567" y="3131481"/>
            <a:ext cx="60625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75-</a:t>
            </a:r>
            <a:endParaRPr lang="en-GB" dirty="0"/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4A2258B4-4A92-4D96-8CE1-EC46CA7F4013}"/>
              </a:ext>
            </a:extLst>
          </p:cNvPr>
          <p:cNvSpPr txBox="1"/>
          <p:nvPr/>
        </p:nvSpPr>
        <p:spPr>
          <a:xfrm>
            <a:off x="3699783" y="4095983"/>
            <a:ext cx="60625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50-</a:t>
            </a:r>
            <a:endParaRPr lang="en-GB" dirty="0"/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154816F3-C45B-4D38-879F-5AFD5FEE8AFA}"/>
              </a:ext>
            </a:extLst>
          </p:cNvPr>
          <p:cNvSpPr txBox="1"/>
          <p:nvPr/>
        </p:nvSpPr>
        <p:spPr>
          <a:xfrm>
            <a:off x="3711614" y="5689486"/>
            <a:ext cx="60625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37-</a:t>
            </a:r>
            <a:endParaRPr lang="en-GB" dirty="0"/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CA46D852-E163-4F86-90E7-B0D289CC9ED7}"/>
              </a:ext>
            </a:extLst>
          </p:cNvPr>
          <p:cNvSpPr txBox="1"/>
          <p:nvPr/>
        </p:nvSpPr>
        <p:spPr>
          <a:xfrm>
            <a:off x="5359079" y="193877"/>
            <a:ext cx="130362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Testes 1-2-3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74235094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40</TotalTime>
  <Words>29</Words>
  <Application>Microsoft Office PowerPoint</Application>
  <PresentationFormat>Widescreen</PresentationFormat>
  <Paragraphs>21</Paragraphs>
  <Slides>3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0</vt:i4>
      </vt:variant>
      <vt:variant>
        <vt:lpstr>Slide Titles</vt:lpstr>
      </vt:variant>
      <vt:variant>
        <vt:i4>3</vt:i4>
      </vt:variant>
    </vt:vector>
  </HeadingPairs>
  <TitlesOfParts>
    <vt:vector size="7" baseType="lpstr">
      <vt:lpstr>Arial</vt:lpstr>
      <vt:lpstr>Calibri</vt:lpstr>
      <vt:lpstr>Calibri Light</vt:lpstr>
      <vt:lpstr>Office Theme</vt:lpstr>
      <vt:lpstr>Figure 1G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Figure 1F</dc:title>
  <dc:creator>Pradipta Ghosh</dc:creator>
  <cp:lastModifiedBy>Pradipta Ghosh</cp:lastModifiedBy>
  <cp:revision>7</cp:revision>
  <dcterms:created xsi:type="dcterms:W3CDTF">2021-04-27T14:41:17Z</dcterms:created>
  <dcterms:modified xsi:type="dcterms:W3CDTF">2021-07-28T01:57:38Z</dcterms:modified>
</cp:coreProperties>
</file>